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90" d="100"/>
          <a:sy n="90" d="100"/>
        </p:scale>
        <p:origin x="-732" y="95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1D49E-F824-4C98-AC4C-2F7A334893C4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247B5-83E6-4381-8394-3D4DA01CD46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8200470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1D49E-F824-4C98-AC4C-2F7A334893C4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247B5-83E6-4381-8394-3D4DA01CD46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7053516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1D49E-F824-4C98-AC4C-2F7A334893C4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247B5-83E6-4381-8394-3D4DA01CD46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271221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1D49E-F824-4C98-AC4C-2F7A334893C4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247B5-83E6-4381-8394-3D4DA01CD46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33467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1D49E-F824-4C98-AC4C-2F7A334893C4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247B5-83E6-4381-8394-3D4DA01CD46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7389611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1D49E-F824-4C98-AC4C-2F7A334893C4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247B5-83E6-4381-8394-3D4DA01CD46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2343178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1D49E-F824-4C98-AC4C-2F7A334893C4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247B5-83E6-4381-8394-3D4DA01CD46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967048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1D49E-F824-4C98-AC4C-2F7A334893C4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247B5-83E6-4381-8394-3D4DA01CD46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928172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1D49E-F824-4C98-AC4C-2F7A334893C4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247B5-83E6-4381-8394-3D4DA01CD46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6570545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1D49E-F824-4C98-AC4C-2F7A334893C4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247B5-83E6-4381-8394-3D4DA01CD46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6442495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1D49E-F824-4C98-AC4C-2F7A334893C4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247B5-83E6-4381-8394-3D4DA01CD46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4198267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31D49E-F824-4C98-AC4C-2F7A334893C4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3247B5-83E6-4381-8394-3D4DA01CD46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8451590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Obrázek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3675" y="44624"/>
            <a:ext cx="3676650" cy="4819650"/>
          </a:xfrm>
          <a:prstGeom prst="rect">
            <a:avLst/>
          </a:prstGeom>
        </p:spPr>
      </p:pic>
      <p:sp>
        <p:nvSpPr>
          <p:cNvPr id="53" name="TextovéPole 52"/>
          <p:cNvSpPr txBox="1"/>
          <p:nvPr/>
        </p:nvSpPr>
        <p:spPr>
          <a:xfrm>
            <a:off x="129566" y="5142212"/>
            <a:ext cx="883492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600" b="1" smtClean="0">
                <a:latin typeface="Arial" panose="020B0604020202020204" pitchFamily="34" charset="0"/>
                <a:cs typeface="Arial" panose="020B0604020202020204" pitchFamily="34" charset="0"/>
              </a:rPr>
              <a:t>S3.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Linear maps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bla</a:t>
            </a:r>
            <a:r>
              <a:rPr lang="en-US" sz="1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OXA-181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-carrying regions. Open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eading frames (ORFs) are shown as rectangles (arrows within rectangles indicate the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direction of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ranscription).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plicons are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ndicated as pink rectangles. Resistance genes,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nd insertion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equence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elements are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hown in red,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nd yellow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spectively. The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emaining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enes are indicated as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gray rectangles. Homologous segments (representing 99% sequence identity) are indicated by light blue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hading.</a:t>
            </a:r>
            <a:endParaRPr lang="cs-CZ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3362689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</TotalTime>
  <Words>79</Words>
  <Application>Microsoft Office PowerPoint</Application>
  <PresentationFormat>Předvádění na obrazovce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ystému Office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papagiannitsis</dc:creator>
  <cp:lastModifiedBy>papagiannitsis</cp:lastModifiedBy>
  <cp:revision>5</cp:revision>
  <dcterms:created xsi:type="dcterms:W3CDTF">2020-03-28T21:00:40Z</dcterms:created>
  <dcterms:modified xsi:type="dcterms:W3CDTF">2021-01-14T11:00:37Z</dcterms:modified>
</cp:coreProperties>
</file>